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67" r:id="rId5"/>
    <p:sldId id="259" r:id="rId6"/>
    <p:sldId id="265" r:id="rId7"/>
    <p:sldId id="261" r:id="rId8"/>
    <p:sldId id="264" r:id="rId9"/>
    <p:sldId id="260" r:id="rId10"/>
    <p:sldId id="266" r:id="rId11"/>
    <p:sldId id="262" r:id="rId12"/>
    <p:sldId id="263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40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5F0CEE-6546-6685-F277-DB3DAF09BB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966412-19F4-ADC5-98DD-E4EF99FFBE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AE5445-B0B1-A410-B9F7-B30D3B74A8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04B48-3D0D-4CF0-AA8E-99B179BC5FFE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F04A8D-40FB-998E-A3C2-28CFDE65CB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394661-7060-6257-FDF9-BF6A22B1D8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E3FD3-5F97-49E4-AFBE-F3D88A87B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419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2506A3-38B3-462D-4DE2-29A7CE5D9F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7F2F1B-344B-6A64-E213-FB4A744F36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2364C9-9F5A-CCF0-624F-835955DF2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04B48-3D0D-4CF0-AA8E-99B179BC5FFE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A71C4D-82A4-9B42-6FC7-916462FA4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6264B2-20C9-BC17-F1E5-B66869107A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E3FD3-5F97-49E4-AFBE-F3D88A87B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206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18BDEE1-359A-B259-968F-557436527A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44B71A-0E45-9446-1DB2-ACFB7EA615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374749-77F2-A3E4-3022-5F1D0AE97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04B48-3D0D-4CF0-AA8E-99B179BC5FFE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5B17B3-FD83-88F0-BC46-87FAF1C3E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66AC9E-42C5-734B-0A0E-7F0549A05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E3FD3-5F97-49E4-AFBE-F3D88A87B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200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F4CE7A-AD1B-0F0F-5E2A-33DB915067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9BE284-91A8-3BC0-2F48-0EE9F0BC7D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9EE158-900A-C263-E0AD-84D5E5630A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04B48-3D0D-4CF0-AA8E-99B179BC5FFE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D38E07-A9B6-EEC8-37A3-89A2077B3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4480E1-A8ED-F249-A134-AAAFF36CC7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E3FD3-5F97-49E4-AFBE-F3D88A87B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365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F10CE7-86AC-63D1-262B-485F54918A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C982E4-39D3-9A71-CA78-B96F6C05CC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0F5683-B56B-B88A-44C8-C84E413DB3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04B48-3D0D-4CF0-AA8E-99B179BC5FFE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1AED9B-DE0C-E0E0-19CE-F0D07EAFB7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516966-A77D-C430-4DB1-090185C5F2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E3FD3-5F97-49E4-AFBE-F3D88A87B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170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3A36E2-AB24-2781-1336-664D29C133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48085A-80F6-87BB-A4BD-6F2EA23098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95CF0A-3DFC-4A8A-C588-3A753755FE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CEB3C0-7BA3-631D-C37C-62118F16A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04B48-3D0D-4CF0-AA8E-99B179BC5FFE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B8B18B-FF8C-4F05-3148-E1C2D490B4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EABB14-7F86-7C2D-DE10-F974B55091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E3FD3-5F97-49E4-AFBE-F3D88A87B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615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E643DA-5FA8-87BB-E825-296DC80BDB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265C66-6D69-681A-126D-28B25106EC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E4DB0D-8EBB-B928-0859-3BBB6AB111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4AF1287-AEEF-E24D-F3AB-06CAF60CBD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80C39FE-07B8-AA72-A8D1-5F7D96AE3B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16FA61E-FE3B-C776-F3CA-0D8B95D07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04B48-3D0D-4CF0-AA8E-99B179BC5FFE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137E94D-83DE-09F0-802C-3877F456F6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A772387-1639-6856-8059-27022A1A1D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E3FD3-5F97-49E4-AFBE-F3D88A87B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653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C70FD7-3226-AC8B-5CA1-EFED374CD9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2DC875A-06CA-E747-80CC-FB13114B56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04B48-3D0D-4CF0-AA8E-99B179BC5FFE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DA0AF8F-85D8-E569-B583-89236D9633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E27510-C3B9-5E69-2C81-B669B4EF1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E3FD3-5F97-49E4-AFBE-F3D88A87B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31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4A19B9-D8CA-C718-4762-A97513971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04B48-3D0D-4CF0-AA8E-99B179BC5FFE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199050-FF82-7893-2A4B-5AEDB54F5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E7C684C-8F2B-DB0C-8022-C3DF35120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E3FD3-5F97-49E4-AFBE-F3D88A87B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403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5E21CF-5D92-04B3-3E60-ADBB2524A5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59EFDC-DEC9-4F01-701D-BC30AEEAF5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97D0BE-DD14-E6E0-BDF8-F5AB71AA5C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8617E3-AF9B-65AB-6E5F-7FD0E2EBF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04B48-3D0D-4CF0-AA8E-99B179BC5FFE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F0D99C-01A3-7118-0497-A43EF9088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237C0B-37F6-20C2-9A79-BA13F974B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E3FD3-5F97-49E4-AFBE-F3D88A87B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113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7AC1A5-96A7-4BC3-2A50-7D9C58C3C7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96C2882-18B0-FD63-8988-0DE14EC8C7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153970-6829-E78F-DF57-F7EDAFA57D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016093-DC08-5B87-BAED-CD7499049A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04B48-3D0D-4CF0-AA8E-99B179BC5FFE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AFA10C-CC1E-F7BB-0628-4E3086C91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9C3BF4-09CD-2D2D-DCD0-06D9D568E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E3FD3-5F97-49E4-AFBE-F3D88A87B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554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1E719B-DA35-E685-82A6-B89388113F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7D1729-1989-D041-556B-130BEA0FCE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F4C58E-40C4-F9BD-52EC-ECC15B0A8B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204B48-3D0D-4CF0-AA8E-99B179BC5FFE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D14577-8275-2270-EB77-960ACFDCD2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194CDC-1899-C6B6-F8B4-72D86A0A68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FE3FD3-5F97-49E4-AFBE-F3D88A87B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7170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7820B1BF-5C0E-3B99-74A6-37D3C5570D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40434" y="1768115"/>
            <a:ext cx="10515600" cy="4351338"/>
          </a:xfrm>
        </p:spPr>
        <p:txBody>
          <a:bodyPr/>
          <a:lstStyle/>
          <a:p>
            <a:pPr marL="0" indent="0" algn="ctr">
              <a:buNone/>
            </a:pP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2</a:t>
            </a:r>
          </a:p>
          <a:p>
            <a:pPr marL="0" indent="0" algn="ctr">
              <a:buNone/>
            </a:pP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Gel Pictures</a:t>
            </a:r>
          </a:p>
        </p:txBody>
      </p:sp>
    </p:spTree>
    <p:extLst>
      <p:ext uri="{BB962C8B-B14F-4D97-AF65-F5344CB8AC3E}">
        <p14:creationId xmlns:p14="http://schemas.microsoft.com/office/powerpoint/2010/main" val="41622453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11AACD7F-D947-D83F-9F8B-8853CD546BD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5143" y="985271"/>
            <a:ext cx="5695338" cy="2286000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01F172B-2D32-03E5-67FA-296FC77595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143" y="3952489"/>
            <a:ext cx="6568686" cy="192024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7932BCA-2CE6-5ECB-CD21-9BD2D1B985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87168" y="985272"/>
            <a:ext cx="5852160" cy="234895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B5BCF2E-A6EC-A3A7-AC07-D74A82DEE6AD}"/>
              </a:ext>
            </a:extLst>
          </p:cNvPr>
          <p:cNvSpPr txBox="1"/>
          <p:nvPr/>
        </p:nvSpPr>
        <p:spPr>
          <a:xfrm>
            <a:off x="8294777" y="646717"/>
            <a:ext cx="152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2B06428-2D50-C9EC-69E2-D2E393182A8F}"/>
              </a:ext>
            </a:extLst>
          </p:cNvPr>
          <p:cNvSpPr txBox="1"/>
          <p:nvPr/>
        </p:nvSpPr>
        <p:spPr>
          <a:xfrm>
            <a:off x="1468812" y="708272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 curv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A862171-93FD-8A5D-2EE1-9A8E7005B741}"/>
              </a:ext>
            </a:extLst>
          </p:cNvPr>
          <p:cNvSpPr txBox="1"/>
          <p:nvPr/>
        </p:nvSpPr>
        <p:spPr>
          <a:xfrm>
            <a:off x="2233687" y="3751037"/>
            <a:ext cx="1865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 peak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D1422E5-A8F9-649A-63B6-5413A78BAD8D}"/>
              </a:ext>
            </a:extLst>
          </p:cNvPr>
          <p:cNvSpPr txBox="1"/>
          <p:nvPr/>
        </p:nvSpPr>
        <p:spPr>
          <a:xfrm>
            <a:off x="1114929" y="3256540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5F13A22-018E-92AE-B104-146B2ABB796C}"/>
              </a:ext>
            </a:extLst>
          </p:cNvPr>
          <p:cNvSpPr txBox="1"/>
          <p:nvPr/>
        </p:nvSpPr>
        <p:spPr>
          <a:xfrm>
            <a:off x="2036490" y="5816361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53EF206-2056-30A6-BB58-1101C427218A}"/>
              </a:ext>
            </a:extLst>
          </p:cNvPr>
          <p:cNvSpPr txBox="1"/>
          <p:nvPr/>
        </p:nvSpPr>
        <p:spPr>
          <a:xfrm>
            <a:off x="732692" y="2435042"/>
            <a:ext cx="226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stant 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-3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775479A-FAFD-424A-73FC-A819465E2C28}"/>
              </a:ext>
            </a:extLst>
          </p:cNvPr>
          <p:cNvSpPr txBox="1"/>
          <p:nvPr/>
        </p:nvSpPr>
        <p:spPr>
          <a:xfrm>
            <a:off x="1475117" y="1542799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ceptible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-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B8C6878-F72A-ECC3-F288-4E684A844E25}"/>
              </a:ext>
            </a:extLst>
          </p:cNvPr>
          <p:cNvSpPr txBox="1"/>
          <p:nvPr/>
        </p:nvSpPr>
        <p:spPr>
          <a:xfrm>
            <a:off x="2757435" y="4801004"/>
            <a:ext cx="226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stant 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-3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CFC4C00-5BB7-71CE-A197-79305A96FD3D}"/>
              </a:ext>
            </a:extLst>
          </p:cNvPr>
          <p:cNvSpPr txBox="1"/>
          <p:nvPr/>
        </p:nvSpPr>
        <p:spPr>
          <a:xfrm>
            <a:off x="2806043" y="4075599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ceptible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-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098BFFE-8ABE-CBAB-6183-8956CE9247F4}"/>
              </a:ext>
            </a:extLst>
          </p:cNvPr>
          <p:cNvSpPr txBox="1"/>
          <p:nvPr/>
        </p:nvSpPr>
        <p:spPr>
          <a:xfrm>
            <a:off x="9386018" y="1783420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4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AC81991-B830-1705-E4D2-9A1DBA3148C7}"/>
              </a:ext>
            </a:extLst>
          </p:cNvPr>
          <p:cNvSpPr txBox="1"/>
          <p:nvPr/>
        </p:nvSpPr>
        <p:spPr>
          <a:xfrm>
            <a:off x="8456830" y="1588966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8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B995EB9-5ABB-C544-7D4E-89A2F0F90362}"/>
              </a:ext>
            </a:extLst>
          </p:cNvPr>
          <p:cNvSpPr txBox="1"/>
          <p:nvPr/>
        </p:nvSpPr>
        <p:spPr>
          <a:xfrm>
            <a:off x="9587004" y="2473514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8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B98E9D8-F428-4521-2CF4-0E9EFC7B24BA}"/>
              </a:ext>
            </a:extLst>
          </p:cNvPr>
          <p:cNvSpPr txBox="1"/>
          <p:nvPr/>
        </p:nvSpPr>
        <p:spPr>
          <a:xfrm>
            <a:off x="10610627" y="2128271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4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A004770-2304-0815-B4CC-8C8106857B50}"/>
              </a:ext>
            </a:extLst>
          </p:cNvPr>
          <p:cNvSpPr txBox="1"/>
          <p:nvPr/>
        </p:nvSpPr>
        <p:spPr>
          <a:xfrm>
            <a:off x="3290018" y="136835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-3 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(EC-127645)- BCMNV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39980409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001BC87-737F-403B-AD59-AC0E69577F9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49528" b="50000"/>
          <a:stretch/>
        </p:blipFill>
        <p:spPr>
          <a:xfrm>
            <a:off x="46006" y="1280160"/>
            <a:ext cx="6153509" cy="215046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CE87071-1B56-E950-2443-2C91698C2B5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49528" b="50000"/>
          <a:stretch/>
        </p:blipFill>
        <p:spPr>
          <a:xfrm>
            <a:off x="6349039" y="1280160"/>
            <a:ext cx="5515054" cy="219456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5A52695-851D-491B-03BA-45D73474768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49528" b="50000"/>
          <a:stretch/>
        </p:blipFill>
        <p:spPr>
          <a:xfrm>
            <a:off x="46006" y="4406166"/>
            <a:ext cx="6153509" cy="1783780"/>
          </a:xfrm>
          <a:prstGeom prst="rect">
            <a:avLst/>
          </a:prstGeom>
        </p:spPr>
      </p:pic>
      <p:sp>
        <p:nvSpPr>
          <p:cNvPr id="10" name="Title 1">
            <a:extLst>
              <a:ext uri="{FF2B5EF4-FFF2-40B4-BE49-F238E27FC236}">
                <a16:creationId xmlns:a16="http://schemas.microsoft.com/office/drawing/2014/main" id="{41B30DE7-9889-9745-B181-271E0CD0D6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89780" y="118303"/>
            <a:ext cx="4786221" cy="338554"/>
          </a:xfrm>
        </p:spPr>
        <p:txBody>
          <a:bodyPr>
            <a:noAutofit/>
          </a:bodyPr>
          <a:lstStyle/>
          <a:p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c-3</a:t>
            </a:r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C-116117)- BCMV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7B5EBAE-AF08-AFC6-7FFE-0158E8EC3F7F}"/>
              </a:ext>
            </a:extLst>
          </p:cNvPr>
          <p:cNvSpPr txBox="1"/>
          <p:nvPr/>
        </p:nvSpPr>
        <p:spPr>
          <a:xfrm>
            <a:off x="7976506" y="3474720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EF86AD1-65B2-FD1C-DF0A-1766C16BAC15}"/>
              </a:ext>
            </a:extLst>
          </p:cNvPr>
          <p:cNvSpPr txBox="1"/>
          <p:nvPr/>
        </p:nvSpPr>
        <p:spPr>
          <a:xfrm>
            <a:off x="1607389" y="6189946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8776C21-1DC5-3D7E-08E8-B83CFCF74220}"/>
              </a:ext>
            </a:extLst>
          </p:cNvPr>
          <p:cNvSpPr txBox="1"/>
          <p:nvPr/>
        </p:nvSpPr>
        <p:spPr>
          <a:xfrm>
            <a:off x="2447026" y="4493033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ceptible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c-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F36D3D2-08BB-6180-B013-C89F5E6026C0}"/>
              </a:ext>
            </a:extLst>
          </p:cNvPr>
          <p:cNvSpPr txBox="1"/>
          <p:nvPr/>
        </p:nvSpPr>
        <p:spPr>
          <a:xfrm>
            <a:off x="7096664" y="1542799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ceptible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c-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7387D19-5537-D672-FF94-883277512E81}"/>
              </a:ext>
            </a:extLst>
          </p:cNvPr>
          <p:cNvSpPr txBox="1"/>
          <p:nvPr/>
        </p:nvSpPr>
        <p:spPr>
          <a:xfrm>
            <a:off x="1695090" y="5033712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stant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c-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92F98DB-D771-E745-9249-B1E983F800DC}"/>
              </a:ext>
            </a:extLst>
          </p:cNvPr>
          <p:cNvSpPr txBox="1"/>
          <p:nvPr/>
        </p:nvSpPr>
        <p:spPr>
          <a:xfrm>
            <a:off x="6643777" y="2454414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stant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c-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9B04CD9-4CE5-9FBD-79E8-1C7C1387A7DF}"/>
              </a:ext>
            </a:extLst>
          </p:cNvPr>
          <p:cNvSpPr txBox="1"/>
          <p:nvPr/>
        </p:nvSpPr>
        <p:spPr>
          <a:xfrm>
            <a:off x="3001992" y="2115830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4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13B61A5-836A-A222-ADE9-3F1BC1EB9D3B}"/>
              </a:ext>
            </a:extLst>
          </p:cNvPr>
          <p:cNvSpPr txBox="1"/>
          <p:nvPr/>
        </p:nvSpPr>
        <p:spPr>
          <a:xfrm>
            <a:off x="1583047" y="2224589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8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B2A96A0-771C-9DB7-7B7D-8304C485F14E}"/>
              </a:ext>
            </a:extLst>
          </p:cNvPr>
          <p:cNvSpPr txBox="1"/>
          <p:nvPr/>
        </p:nvSpPr>
        <p:spPr>
          <a:xfrm>
            <a:off x="4976002" y="2093784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4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26A4035-AD3A-EF8C-7C04-E642B7CC308B}"/>
              </a:ext>
            </a:extLst>
          </p:cNvPr>
          <p:cNvSpPr txBox="1"/>
          <p:nvPr/>
        </p:nvSpPr>
        <p:spPr>
          <a:xfrm>
            <a:off x="3756802" y="2531034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8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5545548-94EE-9CF2-9118-457E6A8E77B3}"/>
              </a:ext>
            </a:extLst>
          </p:cNvPr>
          <p:cNvSpPr txBox="1"/>
          <p:nvPr/>
        </p:nvSpPr>
        <p:spPr>
          <a:xfrm>
            <a:off x="8245070" y="871841"/>
            <a:ext cx="15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 curv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FC999CF-07C0-26C1-0A47-F8C96A0FD09A}"/>
              </a:ext>
            </a:extLst>
          </p:cNvPr>
          <p:cNvSpPr txBox="1"/>
          <p:nvPr/>
        </p:nvSpPr>
        <p:spPr>
          <a:xfrm>
            <a:off x="2017369" y="4098389"/>
            <a:ext cx="18657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 peak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24434D1-4E44-9C59-653E-00B8C0349D22}"/>
              </a:ext>
            </a:extLst>
          </p:cNvPr>
          <p:cNvSpPr txBox="1"/>
          <p:nvPr/>
        </p:nvSpPr>
        <p:spPr>
          <a:xfrm>
            <a:off x="2517473" y="1007852"/>
            <a:ext cx="152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07653510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FEC90041-DB24-9F6B-6B14-E5BB3D615B7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49953" b="50000"/>
          <a:stretch/>
        </p:blipFill>
        <p:spPr>
          <a:xfrm>
            <a:off x="48691" y="928260"/>
            <a:ext cx="6583680" cy="192466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2265BD7-01C1-DB5A-E2C0-20FAB893E85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49612" b="49279"/>
          <a:stretch/>
        </p:blipFill>
        <p:spPr>
          <a:xfrm>
            <a:off x="6884156" y="979060"/>
            <a:ext cx="5063895" cy="27432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3E14771-D3B3-A674-06E9-292C2651191C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49803" b="49961"/>
          <a:stretch/>
        </p:blipFill>
        <p:spPr>
          <a:xfrm>
            <a:off x="568579" y="3375903"/>
            <a:ext cx="5543905" cy="297409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712367F7-1238-BA36-01DB-DC5DFD37970C}"/>
              </a:ext>
            </a:extLst>
          </p:cNvPr>
          <p:cNvSpPr txBox="1"/>
          <p:nvPr/>
        </p:nvSpPr>
        <p:spPr>
          <a:xfrm>
            <a:off x="2549172" y="3974561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8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9DEDB82-7CFF-9CBE-E6FC-722E860A1EB3}"/>
              </a:ext>
            </a:extLst>
          </p:cNvPr>
          <p:cNvSpPr txBox="1"/>
          <p:nvPr/>
        </p:nvSpPr>
        <p:spPr>
          <a:xfrm>
            <a:off x="3268656" y="4397116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4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65D9F38-3348-B1EF-AB51-934B9BAEEC9D}"/>
              </a:ext>
            </a:extLst>
          </p:cNvPr>
          <p:cNvSpPr txBox="1"/>
          <p:nvPr/>
        </p:nvSpPr>
        <p:spPr>
          <a:xfrm>
            <a:off x="3701414" y="5418329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8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9E11003-C184-A0F0-3A4A-5C53DFA25487}"/>
              </a:ext>
            </a:extLst>
          </p:cNvPr>
          <p:cNvSpPr txBox="1"/>
          <p:nvPr/>
        </p:nvSpPr>
        <p:spPr>
          <a:xfrm>
            <a:off x="5034059" y="4527921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4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2E4D667-8DA8-DE62-9103-B8EF3BD0ED2E}"/>
              </a:ext>
            </a:extLst>
          </p:cNvPr>
          <p:cNvSpPr txBox="1"/>
          <p:nvPr/>
        </p:nvSpPr>
        <p:spPr>
          <a:xfrm>
            <a:off x="2138596" y="928260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ceptible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c-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71F3450-D624-8BBE-B34A-544C34B5B496}"/>
              </a:ext>
            </a:extLst>
          </p:cNvPr>
          <p:cNvSpPr txBox="1"/>
          <p:nvPr/>
        </p:nvSpPr>
        <p:spPr>
          <a:xfrm>
            <a:off x="2773939" y="1773896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stant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c-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9E7126F-7AF4-AF68-CC5D-A8E5776D1CEB}"/>
              </a:ext>
            </a:extLst>
          </p:cNvPr>
          <p:cNvSpPr txBox="1"/>
          <p:nvPr/>
        </p:nvSpPr>
        <p:spPr>
          <a:xfrm>
            <a:off x="7155983" y="2545151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stant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c-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DFC91A1-9A11-72C3-A4F3-4DE50C432DE1}"/>
              </a:ext>
            </a:extLst>
          </p:cNvPr>
          <p:cNvSpPr txBox="1"/>
          <p:nvPr/>
        </p:nvSpPr>
        <p:spPr>
          <a:xfrm>
            <a:off x="8286043" y="1620007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ceptible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c-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75094F0-7632-EFB3-0A32-A5D151ABD19C}"/>
              </a:ext>
            </a:extLst>
          </p:cNvPr>
          <p:cNvSpPr txBox="1"/>
          <p:nvPr/>
        </p:nvSpPr>
        <p:spPr>
          <a:xfrm>
            <a:off x="8404727" y="671283"/>
            <a:ext cx="15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 curv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9CDE8A3-178D-37E7-DB95-F7347805F4B8}"/>
              </a:ext>
            </a:extLst>
          </p:cNvPr>
          <p:cNvSpPr txBox="1"/>
          <p:nvPr/>
        </p:nvSpPr>
        <p:spPr>
          <a:xfrm>
            <a:off x="2138596" y="598795"/>
            <a:ext cx="18657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 peak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3C40F90-0842-BF50-DADC-C6B1D786BACD}"/>
              </a:ext>
            </a:extLst>
          </p:cNvPr>
          <p:cNvSpPr txBox="1"/>
          <p:nvPr/>
        </p:nvSpPr>
        <p:spPr>
          <a:xfrm>
            <a:off x="2379999" y="3102886"/>
            <a:ext cx="152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FEC7FB0-B32D-8832-8A9A-280DC3E1806A}"/>
              </a:ext>
            </a:extLst>
          </p:cNvPr>
          <p:cNvSpPr txBox="1"/>
          <p:nvPr/>
        </p:nvSpPr>
        <p:spPr>
          <a:xfrm>
            <a:off x="171514" y="2869100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43CCE81-9207-CBEC-5A0F-7762F42A6391}"/>
              </a:ext>
            </a:extLst>
          </p:cNvPr>
          <p:cNvSpPr txBox="1"/>
          <p:nvPr/>
        </p:nvSpPr>
        <p:spPr>
          <a:xfrm>
            <a:off x="8404727" y="3666784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080D7E1-E468-10DA-34A2-1FA59FF74964}"/>
              </a:ext>
            </a:extLst>
          </p:cNvPr>
          <p:cNvSpPr txBox="1"/>
          <p:nvPr/>
        </p:nvSpPr>
        <p:spPr>
          <a:xfrm>
            <a:off x="2379999" y="112570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c-3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C-116117)- BCMN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767961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A932C65-1CE7-4E41-C04B-455CB95447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30" y="553516"/>
            <a:ext cx="5943600" cy="4754880"/>
          </a:xfrm>
          <a:prstGeom prst="rect">
            <a:avLst/>
          </a:prstGeom>
        </p:spPr>
      </p:pic>
      <p:pic>
        <p:nvPicPr>
          <p:cNvPr id="6" name="Content Placeholder 4">
            <a:extLst>
              <a:ext uri="{FF2B5EF4-FFF2-40B4-BE49-F238E27FC236}">
                <a16:creationId xmlns:a16="http://schemas.microsoft.com/office/drawing/2014/main" id="{0935FCF1-D419-5FAD-BCC8-EAA3750161A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553516"/>
            <a:ext cx="5943600" cy="475488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A42B01A-CFBB-1EF0-90CF-C9821C75C39C}"/>
              </a:ext>
            </a:extLst>
          </p:cNvPr>
          <p:cNvSpPr txBox="1"/>
          <p:nvPr/>
        </p:nvSpPr>
        <p:spPr>
          <a:xfrm>
            <a:off x="185468" y="5434643"/>
            <a:ext cx="11821064" cy="12631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Aft>
                <a:spcPts val="800"/>
              </a:spcAft>
            </a:pP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4.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dentification of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 for resistance in the screened germplasm. (a) SW13 marker identified hypersensitive resistant genotypes bearing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 in which 3 cultivars are still susceptible with a disease scale of “2”. (b) CAPS marker identified and cleaved only resistant genotypes whereas, susceptible genotypes remain un-cleaved by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q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. This marker yields two alleles. The resistant allele has two bands (200 and 100 bp), whereas the susceptible allele has a single band (311 bp).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6DAD9A12-F104-2457-0B8A-0DC6D5D7D2C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628866"/>
            <a:ext cx="153670" cy="18288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09428B8-9F6E-6DA2-A268-80517C9A4D3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2839" y="628866"/>
            <a:ext cx="182880" cy="182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09283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27CFA878-592E-EC57-AD9F-2CD575393CA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7381" y="514410"/>
            <a:ext cx="5714999" cy="4572000"/>
          </a:xfrm>
        </p:spPr>
      </p:pic>
      <p:pic>
        <p:nvPicPr>
          <p:cNvPr id="6" name="Content Placeholder 4">
            <a:extLst>
              <a:ext uri="{FF2B5EF4-FFF2-40B4-BE49-F238E27FC236}">
                <a16:creationId xmlns:a16="http://schemas.microsoft.com/office/drawing/2014/main" id="{EF4B894C-6965-46E0-DA71-A5E0E6F3AFE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620" y="514410"/>
            <a:ext cx="5486399" cy="438912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62C8AC9-EDDE-DB7A-7B32-9250075BF8A2}"/>
              </a:ext>
            </a:extLst>
          </p:cNvPr>
          <p:cNvSpPr txBox="1"/>
          <p:nvPr/>
        </p:nvSpPr>
        <p:spPr>
          <a:xfrm>
            <a:off x="983411" y="5216937"/>
            <a:ext cx="9949132" cy="12631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Aft>
                <a:spcPts val="800"/>
              </a:spcAft>
            </a:pP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7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 RT-PCR confirmation of presence of virus in the symptomatic and susceptible genotypes using BCMV-CP primers, (a) M:1kb DNA ladder, 1&amp;3: Negative Controls (RNA isolated from Resistant Plants), 2: Positive control, 4-8: RNA isolated from susceptible genotypes. (b) M: 1kb DNA ladder, 1-16: Susceptible genotypes.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BCA00DE3-371F-D211-7ABB-9C3EDF591E8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70" y="726344"/>
            <a:ext cx="153670" cy="18288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9C9A2F5-A60A-7E74-D43F-2ACDA68FA43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6838" y="863504"/>
            <a:ext cx="182880" cy="182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11987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FC1499E2-D824-EFA8-7E6B-78FAE2D78B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125" y="301867"/>
            <a:ext cx="7559040" cy="604723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FDE24FC-FBD8-5E97-46A7-5981CF01E30D}"/>
              </a:ext>
            </a:extLst>
          </p:cNvPr>
          <p:cNvSpPr txBox="1"/>
          <p:nvPr/>
        </p:nvSpPr>
        <p:spPr>
          <a:xfrm>
            <a:off x="7943203" y="449026"/>
            <a:ext cx="4248797" cy="24505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Aft>
                <a:spcPts val="800"/>
              </a:spcAft>
            </a:pPr>
            <a:r>
              <a:rPr lang="en-US" sz="16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7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 RT-PCR confirmation of presence of virus in the symptomatic and susceptible genotypes using BCMNV CP primers, (c) RT-PCR amplification of BCMNV in susceptible genotypes, Lane M: 1kb DNA ladder, Lane 1: BCMNV positive control, Lane 2-5: Susceptible genotypes, Lane 6-8: Resistant genotypes (Negative control), Lane 9-12: Susceptible genotypes.</a:t>
            </a:r>
            <a:r>
              <a:rPr lang="en-US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501E6B1F-6B8A-B4CE-2124-81B47378B9C0}"/>
              </a:ext>
            </a:extLst>
          </p:cNvPr>
          <p:cNvCxnSpPr/>
          <p:nvPr/>
        </p:nvCxnSpPr>
        <p:spPr>
          <a:xfrm>
            <a:off x="2145102" y="3091133"/>
            <a:ext cx="1616015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35E06868-8B5F-E0A0-BEF4-1A13457B5727}"/>
              </a:ext>
            </a:extLst>
          </p:cNvPr>
          <p:cNvCxnSpPr/>
          <p:nvPr/>
        </p:nvCxnSpPr>
        <p:spPr>
          <a:xfrm>
            <a:off x="3933645" y="3091133"/>
            <a:ext cx="1616015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C5725C8F-27F8-B079-5D41-28B778470B4F}"/>
              </a:ext>
            </a:extLst>
          </p:cNvPr>
          <p:cNvSpPr txBox="1"/>
          <p:nvPr/>
        </p:nvSpPr>
        <p:spPr>
          <a:xfrm>
            <a:off x="2352136" y="3140817"/>
            <a:ext cx="1052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kern="1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CMNV</a:t>
            </a:r>
            <a:endParaRPr lang="en-US" dirty="0">
              <a:highlight>
                <a:srgbClr val="FFFF00"/>
              </a:highlight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81C113E-98B8-DFFC-C048-586AC0BC4786}"/>
              </a:ext>
            </a:extLst>
          </p:cNvPr>
          <p:cNvSpPr txBox="1"/>
          <p:nvPr/>
        </p:nvSpPr>
        <p:spPr>
          <a:xfrm>
            <a:off x="4431102" y="3140817"/>
            <a:ext cx="9172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kern="1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CMV</a:t>
            </a:r>
            <a:endParaRPr lang="en-US" dirty="0">
              <a:highlight>
                <a:srgbClr val="FFFF00"/>
              </a:highlight>
            </a:endParaRPr>
          </a:p>
        </p:txBody>
      </p:sp>
      <p:pic>
        <p:nvPicPr>
          <p:cNvPr id="16" name="Picture 8">
            <a:extLst>
              <a:ext uri="{FF2B5EF4-FFF2-40B4-BE49-F238E27FC236}">
                <a16:creationId xmlns:a16="http://schemas.microsoft.com/office/drawing/2014/main" id="{888A6D77-C449-0955-688A-E937F3843C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290" y="6065217"/>
            <a:ext cx="179726" cy="1828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295116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EC022C56-ECD3-32BE-5420-124EB17C79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30" y="405729"/>
            <a:ext cx="6629400" cy="530352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B02AC3B-89AF-61A7-F626-27C1E6C21272}"/>
              </a:ext>
            </a:extLst>
          </p:cNvPr>
          <p:cNvSpPr txBox="1"/>
          <p:nvPr/>
        </p:nvSpPr>
        <p:spPr>
          <a:xfrm>
            <a:off x="6757359" y="405729"/>
            <a:ext cx="5204603" cy="22495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Aft>
                <a:spcPts val="800"/>
              </a:spcAft>
            </a:pP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dentification of </a:t>
            </a:r>
            <a:r>
              <a:rPr lang="en-US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c-3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 for resistance in the screened germplasm</a:t>
            </a:r>
            <a:r>
              <a:rPr 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C11/420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arker that identified resistant genotypes bearing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c-3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. (Figure not included in </a:t>
            </a:r>
            <a:r>
              <a:rPr lang="en-US" sz="18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in text).</a:t>
            </a:r>
            <a:endParaRPr lang="en-US" sz="18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107000"/>
              </a:lnSpc>
              <a:spcAft>
                <a:spcPts val="800"/>
              </a:spcAft>
            </a:pPr>
            <a:r>
              <a:rPr 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sitive signals indicate the absence of </a:t>
            </a:r>
            <a:r>
              <a:rPr lang="en-US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c-3</a:t>
            </a:r>
            <a:r>
              <a:rPr 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 and negative (Un-amplified) signals indicate the presence of </a:t>
            </a:r>
            <a:r>
              <a:rPr lang="en-US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c-3</a:t>
            </a:r>
            <a:r>
              <a:rPr 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.</a:t>
            </a:r>
          </a:p>
        </p:txBody>
      </p:sp>
    </p:spTree>
    <p:extLst>
      <p:ext uri="{BB962C8B-B14F-4D97-AF65-F5344CB8AC3E}">
        <p14:creationId xmlns:p14="http://schemas.microsoft.com/office/powerpoint/2010/main" val="9357635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217FF1-F8BC-5997-2C59-0958D19459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 algn="ctr">
              <a:buNone/>
            </a:pP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SOCIATION CURVES OF BCMV-BCMNV </a:t>
            </a:r>
          </a:p>
        </p:txBody>
      </p:sp>
    </p:spTree>
    <p:extLst>
      <p:ext uri="{BB962C8B-B14F-4D97-AF65-F5344CB8AC3E}">
        <p14:creationId xmlns:p14="http://schemas.microsoft.com/office/powerpoint/2010/main" val="19840150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0EA982-99D7-3FEA-6CB3-030BDCFE4C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89781" y="118303"/>
            <a:ext cx="3025133" cy="285183"/>
          </a:xfrm>
        </p:spPr>
        <p:txBody>
          <a:bodyPr>
            <a:noAutofit/>
          </a:bodyPr>
          <a:lstStyle/>
          <a:p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(WB-352)- BCMV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CA40D52-251F-0023-2B25-4972B5F1968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-1" r="49812" b="49795"/>
          <a:stretch/>
        </p:blipFill>
        <p:spPr>
          <a:xfrm>
            <a:off x="68197" y="1043495"/>
            <a:ext cx="6119004" cy="245867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65692A1-190F-53A5-464A-77639FBD058B}"/>
              </a:ext>
            </a:extLst>
          </p:cNvPr>
          <p:cNvSpPr txBox="1"/>
          <p:nvPr/>
        </p:nvSpPr>
        <p:spPr>
          <a:xfrm>
            <a:off x="1475117" y="1542799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ceptible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067F54EE-29A3-EEAF-C8B5-4C7D85102EB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50187" b="49865"/>
          <a:stretch/>
        </p:blipFill>
        <p:spPr>
          <a:xfrm>
            <a:off x="6187201" y="562050"/>
            <a:ext cx="5389448" cy="27432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3DB7986-E2C0-671F-B5E9-12B2DAA940DF}"/>
              </a:ext>
            </a:extLst>
          </p:cNvPr>
          <p:cNvSpPr txBox="1"/>
          <p:nvPr/>
        </p:nvSpPr>
        <p:spPr>
          <a:xfrm>
            <a:off x="7401464" y="615004"/>
            <a:ext cx="226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ceptible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293D32F-5BD7-C9AC-C296-515040A970D7}"/>
              </a:ext>
            </a:extLst>
          </p:cNvPr>
          <p:cNvSpPr txBox="1"/>
          <p:nvPr/>
        </p:nvSpPr>
        <p:spPr>
          <a:xfrm>
            <a:off x="838200" y="2490585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stant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C78BC6D-FDC4-9A36-7B3A-578A59A5A9B8}"/>
              </a:ext>
            </a:extLst>
          </p:cNvPr>
          <p:cNvSpPr txBox="1"/>
          <p:nvPr/>
        </p:nvSpPr>
        <p:spPr>
          <a:xfrm>
            <a:off x="7451596" y="1960127"/>
            <a:ext cx="226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stan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903F6B40-05D5-1EDC-5A3F-F6DB680CC7DB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49811" b="49795"/>
          <a:stretch/>
        </p:blipFill>
        <p:spPr>
          <a:xfrm>
            <a:off x="189781" y="3892000"/>
            <a:ext cx="6119004" cy="2458679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DCA9D381-F7AC-71B4-5261-D637A24F2061}"/>
              </a:ext>
            </a:extLst>
          </p:cNvPr>
          <p:cNvSpPr txBox="1"/>
          <p:nvPr/>
        </p:nvSpPr>
        <p:spPr>
          <a:xfrm>
            <a:off x="3724898" y="4555790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4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C242719-4329-A47B-22CC-89B9FB2AAEFB}"/>
              </a:ext>
            </a:extLst>
          </p:cNvPr>
          <p:cNvSpPr txBox="1"/>
          <p:nvPr/>
        </p:nvSpPr>
        <p:spPr>
          <a:xfrm>
            <a:off x="2440658" y="4599288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8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18AB3B0-4C60-081D-AF2E-5E84AC113D64}"/>
              </a:ext>
            </a:extLst>
          </p:cNvPr>
          <p:cNvSpPr txBox="1"/>
          <p:nvPr/>
        </p:nvSpPr>
        <p:spPr>
          <a:xfrm>
            <a:off x="4790536" y="5319042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4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5EDC0EB-6C44-A87E-B09B-B6B46D506A24}"/>
              </a:ext>
            </a:extLst>
          </p:cNvPr>
          <p:cNvSpPr txBox="1"/>
          <p:nvPr/>
        </p:nvSpPr>
        <p:spPr>
          <a:xfrm>
            <a:off x="3735237" y="5481189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8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FC9FD46-316C-21B7-B36B-408C637B78AF}"/>
              </a:ext>
            </a:extLst>
          </p:cNvPr>
          <p:cNvSpPr txBox="1"/>
          <p:nvPr/>
        </p:nvSpPr>
        <p:spPr>
          <a:xfrm>
            <a:off x="7648793" y="285051"/>
            <a:ext cx="1865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 peak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A1D4D24-44A7-3482-2499-DB084E6EB8C6}"/>
              </a:ext>
            </a:extLst>
          </p:cNvPr>
          <p:cNvSpPr txBox="1"/>
          <p:nvPr/>
        </p:nvSpPr>
        <p:spPr>
          <a:xfrm>
            <a:off x="345057" y="3476316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F32FE0D-3D72-805C-147C-45B97B024819}"/>
              </a:ext>
            </a:extLst>
          </p:cNvPr>
          <p:cNvSpPr txBox="1"/>
          <p:nvPr/>
        </p:nvSpPr>
        <p:spPr>
          <a:xfrm>
            <a:off x="6516633" y="3275111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1D3DD55-523E-DF24-A795-BCB4309BBDFB}"/>
              </a:ext>
            </a:extLst>
          </p:cNvPr>
          <p:cNvSpPr txBox="1"/>
          <p:nvPr/>
        </p:nvSpPr>
        <p:spPr>
          <a:xfrm>
            <a:off x="2363637" y="3635284"/>
            <a:ext cx="152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B869609-6929-8978-23C4-209B09E33627}"/>
              </a:ext>
            </a:extLst>
          </p:cNvPr>
          <p:cNvSpPr txBox="1"/>
          <p:nvPr/>
        </p:nvSpPr>
        <p:spPr>
          <a:xfrm>
            <a:off x="1930878" y="788324"/>
            <a:ext cx="152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 curve</a:t>
            </a:r>
          </a:p>
        </p:txBody>
      </p:sp>
    </p:spTree>
    <p:extLst>
      <p:ext uri="{BB962C8B-B14F-4D97-AF65-F5344CB8AC3E}">
        <p14:creationId xmlns:p14="http://schemas.microsoft.com/office/powerpoint/2010/main" val="1677075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38C009E-ABE0-A925-40E6-AE7FA1F60B3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49524" b="50000"/>
          <a:stretch/>
        </p:blipFill>
        <p:spPr>
          <a:xfrm>
            <a:off x="6096000" y="1401300"/>
            <a:ext cx="6126480" cy="243764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5FBAA78-E6EC-70AF-72C1-64153C7E6F8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49524" b="50000"/>
          <a:stretch/>
        </p:blipFill>
        <p:spPr>
          <a:xfrm>
            <a:off x="77443" y="1325880"/>
            <a:ext cx="6018557" cy="210312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6BF0F6E-BB29-776A-1D51-09957D155B9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49750" b="47886"/>
          <a:stretch/>
        </p:blipFill>
        <p:spPr>
          <a:xfrm>
            <a:off x="290286" y="4460993"/>
            <a:ext cx="6126480" cy="18592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27973F6-8D5A-2555-57C0-AAEC5BF6781F}"/>
              </a:ext>
            </a:extLst>
          </p:cNvPr>
          <p:cNvSpPr txBox="1"/>
          <p:nvPr/>
        </p:nvSpPr>
        <p:spPr>
          <a:xfrm>
            <a:off x="8397240" y="1040506"/>
            <a:ext cx="152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 curv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946A777-62B4-91D5-7C5F-3ACAF5C16EDE}"/>
              </a:ext>
            </a:extLst>
          </p:cNvPr>
          <p:cNvSpPr txBox="1"/>
          <p:nvPr/>
        </p:nvSpPr>
        <p:spPr>
          <a:xfrm>
            <a:off x="2153858" y="4183994"/>
            <a:ext cx="1865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 peak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E1A5927-3C6D-5755-B61E-BF7699F2EB58}"/>
              </a:ext>
            </a:extLst>
          </p:cNvPr>
          <p:cNvSpPr txBox="1"/>
          <p:nvPr/>
        </p:nvSpPr>
        <p:spPr>
          <a:xfrm>
            <a:off x="2086771" y="6264015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27065D1-4AEA-DA54-5958-48D2F655687F}"/>
              </a:ext>
            </a:extLst>
          </p:cNvPr>
          <p:cNvSpPr txBox="1"/>
          <p:nvPr/>
        </p:nvSpPr>
        <p:spPr>
          <a:xfrm>
            <a:off x="8029180" y="3914362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B7EB6DE-8FB5-1C04-4626-C8AA447A6904}"/>
              </a:ext>
            </a:extLst>
          </p:cNvPr>
          <p:cNvSpPr txBox="1"/>
          <p:nvPr/>
        </p:nvSpPr>
        <p:spPr>
          <a:xfrm>
            <a:off x="2556431" y="4472274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ceptible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09F0D63-2A8B-D2F7-E057-F492F39DBE8B}"/>
              </a:ext>
            </a:extLst>
          </p:cNvPr>
          <p:cNvSpPr txBox="1"/>
          <p:nvPr/>
        </p:nvSpPr>
        <p:spPr>
          <a:xfrm>
            <a:off x="6602510" y="2751156"/>
            <a:ext cx="226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stant 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46DE5E8-3CFC-E8A5-5036-D144179BC3EC}"/>
              </a:ext>
            </a:extLst>
          </p:cNvPr>
          <p:cNvSpPr txBox="1"/>
          <p:nvPr/>
        </p:nvSpPr>
        <p:spPr>
          <a:xfrm>
            <a:off x="7672717" y="1985485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ceptible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764367C-5A31-07F2-36AE-33BF2FC7E346}"/>
              </a:ext>
            </a:extLst>
          </p:cNvPr>
          <p:cNvSpPr txBox="1"/>
          <p:nvPr/>
        </p:nvSpPr>
        <p:spPr>
          <a:xfrm>
            <a:off x="2473195" y="5380845"/>
            <a:ext cx="226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stan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F9CBEE4-39A2-A249-53BD-62B9BBCAC855}"/>
              </a:ext>
            </a:extLst>
          </p:cNvPr>
          <p:cNvSpPr txBox="1"/>
          <p:nvPr/>
        </p:nvSpPr>
        <p:spPr>
          <a:xfrm>
            <a:off x="2162491" y="1062746"/>
            <a:ext cx="152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6A20913-F3A1-1A91-EB69-D26C14F34B11}"/>
              </a:ext>
            </a:extLst>
          </p:cNvPr>
          <p:cNvSpPr txBox="1"/>
          <p:nvPr/>
        </p:nvSpPr>
        <p:spPr>
          <a:xfrm>
            <a:off x="3417019" y="2181536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4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FC3D327-B375-92A3-FB02-5708BFCBED38}"/>
              </a:ext>
            </a:extLst>
          </p:cNvPr>
          <p:cNvSpPr txBox="1"/>
          <p:nvPr/>
        </p:nvSpPr>
        <p:spPr>
          <a:xfrm>
            <a:off x="1967950" y="2293262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8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966B514-7240-B4B3-2D05-BB29100A8840}"/>
              </a:ext>
            </a:extLst>
          </p:cNvPr>
          <p:cNvSpPr txBox="1"/>
          <p:nvPr/>
        </p:nvSpPr>
        <p:spPr>
          <a:xfrm>
            <a:off x="3417019" y="2773538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u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8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0CA42D5-DA93-167C-0853-A44A196170F0}"/>
              </a:ext>
            </a:extLst>
          </p:cNvPr>
          <p:cNvSpPr txBox="1"/>
          <p:nvPr/>
        </p:nvSpPr>
        <p:spPr>
          <a:xfrm>
            <a:off x="4723973" y="2293262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4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itle 1">
            <a:extLst>
              <a:ext uri="{FF2B5EF4-FFF2-40B4-BE49-F238E27FC236}">
                <a16:creationId xmlns:a16="http://schemas.microsoft.com/office/drawing/2014/main" id="{3C3F4B3E-9A5F-B826-A418-E29275238F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89781" y="118303"/>
            <a:ext cx="3025133" cy="285183"/>
          </a:xfrm>
        </p:spPr>
        <p:txBody>
          <a:bodyPr>
            <a:noAutofit/>
          </a:bodyPr>
          <a:lstStyle/>
          <a:p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(WB-352)- BCMNV</a:t>
            </a:r>
          </a:p>
        </p:txBody>
      </p:sp>
    </p:spTree>
    <p:extLst>
      <p:ext uri="{BB962C8B-B14F-4D97-AF65-F5344CB8AC3E}">
        <p14:creationId xmlns:p14="http://schemas.microsoft.com/office/powerpoint/2010/main" val="10371686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D7BB85-A4FA-2486-1DDF-3313A111CC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34228" y="146590"/>
            <a:ext cx="5508171" cy="836822"/>
          </a:xfrm>
        </p:spPr>
        <p:txBody>
          <a:bodyPr>
            <a:noAutofit/>
          </a:bodyPr>
          <a:lstStyle/>
          <a:p>
            <a:pPr algn="ctr"/>
            <a:r>
              <a:rPr lang="en-US" sz="2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-3 </a:t>
            </a:r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(EC-127645)- BCMV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76672B04-1ABB-18B0-BD01-A7E2857D399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083" y="3864696"/>
            <a:ext cx="5099121" cy="2743200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6F3EED0-2E24-3661-DEED-EC4E6B61015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083" y="1279561"/>
            <a:ext cx="6400800" cy="187116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56EF9B3-8C44-E6E9-7E57-7A1652B3F9EB}"/>
              </a:ext>
            </a:extLst>
          </p:cNvPr>
          <p:cNvSpPr txBox="1"/>
          <p:nvPr/>
        </p:nvSpPr>
        <p:spPr>
          <a:xfrm>
            <a:off x="1741781" y="934664"/>
            <a:ext cx="1865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 peak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F0B51DE-3CA9-E3F0-11E4-7F672C083E54}"/>
              </a:ext>
            </a:extLst>
          </p:cNvPr>
          <p:cNvSpPr txBox="1"/>
          <p:nvPr/>
        </p:nvSpPr>
        <p:spPr>
          <a:xfrm>
            <a:off x="1190901" y="3587697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 curv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3B70294-32E0-F64D-CCA5-A07F75EC2821}"/>
              </a:ext>
            </a:extLst>
          </p:cNvPr>
          <p:cNvSpPr txBox="1"/>
          <p:nvPr/>
        </p:nvSpPr>
        <p:spPr>
          <a:xfrm>
            <a:off x="7939632" y="3581925"/>
            <a:ext cx="152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1FD8F61-8CF5-6812-8589-00CB47A68365}"/>
              </a:ext>
            </a:extLst>
          </p:cNvPr>
          <p:cNvSpPr txBox="1"/>
          <p:nvPr/>
        </p:nvSpPr>
        <p:spPr>
          <a:xfrm>
            <a:off x="2162355" y="3223342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508AC23-3DC0-C55C-F454-87B9F14A3DEA}"/>
              </a:ext>
            </a:extLst>
          </p:cNvPr>
          <p:cNvSpPr txBox="1"/>
          <p:nvPr/>
        </p:nvSpPr>
        <p:spPr>
          <a:xfrm>
            <a:off x="1408981" y="6557546"/>
            <a:ext cx="226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21D1F790-D721-282A-0D02-FD37C8CD961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49069" b="45669"/>
          <a:stretch/>
        </p:blipFill>
        <p:spPr>
          <a:xfrm>
            <a:off x="5532407" y="3920479"/>
            <a:ext cx="6534509" cy="2422812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021DFF0B-B54B-C605-9960-781C975EC575}"/>
              </a:ext>
            </a:extLst>
          </p:cNvPr>
          <p:cNvSpPr txBox="1"/>
          <p:nvPr/>
        </p:nvSpPr>
        <p:spPr>
          <a:xfrm>
            <a:off x="8259654" y="5290400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4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5F4E6E8-1016-9CD1-7FFF-8AAEABF95D5A}"/>
              </a:ext>
            </a:extLst>
          </p:cNvPr>
          <p:cNvSpPr txBox="1"/>
          <p:nvPr/>
        </p:nvSpPr>
        <p:spPr>
          <a:xfrm>
            <a:off x="7394137" y="4690236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8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E4A6811-5E32-7CC6-6FB4-87A54C8384C1}"/>
              </a:ext>
            </a:extLst>
          </p:cNvPr>
          <p:cNvSpPr txBox="1"/>
          <p:nvPr/>
        </p:nvSpPr>
        <p:spPr>
          <a:xfrm>
            <a:off x="9834113" y="5236296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4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49D3446-CB19-EEEE-249A-1BAE068E82E6}"/>
              </a:ext>
            </a:extLst>
          </p:cNvPr>
          <p:cNvSpPr txBox="1"/>
          <p:nvPr/>
        </p:nvSpPr>
        <p:spPr>
          <a:xfrm>
            <a:off x="9463632" y="4739470"/>
            <a:ext cx="86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8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6549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</TotalTime>
  <Words>560</Words>
  <Application>Microsoft Office PowerPoint</Application>
  <PresentationFormat>Widescreen</PresentationFormat>
  <Paragraphs>90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I gene (WB-352)- BCMV</vt:lpstr>
      <vt:lpstr>I gene (WB-352)- BCMNV</vt:lpstr>
      <vt:lpstr>bc-3 gene (EC-127645)- BCMV</vt:lpstr>
      <vt:lpstr>PowerPoint Presentation</vt:lpstr>
      <vt:lpstr>Ibc-3 (EC-116117)- BCMV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sari meghanath</dc:creator>
  <cp:lastModifiedBy>dasari meghanath</cp:lastModifiedBy>
  <cp:revision>5</cp:revision>
  <dcterms:created xsi:type="dcterms:W3CDTF">2025-04-18T06:08:48Z</dcterms:created>
  <dcterms:modified xsi:type="dcterms:W3CDTF">2025-05-23T16:06:13Z</dcterms:modified>
</cp:coreProperties>
</file>